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59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57"/>
    <p:restoredTop sz="94519"/>
  </p:normalViewPr>
  <p:slideViewPr>
    <p:cSldViewPr snapToGrid="0">
      <p:cViewPr varScale="1">
        <p:scale>
          <a:sx n="130" d="100"/>
          <a:sy n="130" d="100"/>
        </p:scale>
        <p:origin x="4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4BABC6F-00AC-EF2E-D144-9728496A91C9}"/>
              </a:ext>
            </a:extLst>
          </p:cNvPr>
          <p:cNvSpPr txBox="1"/>
          <p:nvPr/>
        </p:nvSpPr>
        <p:spPr>
          <a:xfrm>
            <a:off x="604684" y="212376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4E1AC8F3-EF95-0F31-90EF-0E716CBAD0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3378503"/>
              </p:ext>
            </p:extLst>
          </p:nvPr>
        </p:nvGraphicFramePr>
        <p:xfrm>
          <a:off x="427703" y="1596256"/>
          <a:ext cx="5674965" cy="3869824"/>
        </p:xfrm>
        <a:graphic>
          <a:graphicData uri="http://schemas.openxmlformats.org/drawingml/2006/table">
            <a:tbl>
              <a:tblPr/>
              <a:tblGrid>
                <a:gridCol w="3007965">
                  <a:extLst>
                    <a:ext uri="{9D8B030D-6E8A-4147-A177-3AD203B41FA5}">
                      <a16:colId xmlns:a16="http://schemas.microsoft.com/office/drawing/2014/main" val="3748562349"/>
                    </a:ext>
                  </a:extLst>
                </a:gridCol>
                <a:gridCol w="666750">
                  <a:extLst>
                    <a:ext uri="{9D8B030D-6E8A-4147-A177-3AD203B41FA5}">
                      <a16:colId xmlns:a16="http://schemas.microsoft.com/office/drawing/2014/main" val="3211129031"/>
                    </a:ext>
                  </a:extLst>
                </a:gridCol>
                <a:gridCol w="666750">
                  <a:extLst>
                    <a:ext uri="{9D8B030D-6E8A-4147-A177-3AD203B41FA5}">
                      <a16:colId xmlns:a16="http://schemas.microsoft.com/office/drawing/2014/main" val="2179213572"/>
                    </a:ext>
                  </a:extLst>
                </a:gridCol>
                <a:gridCol w="666750">
                  <a:extLst>
                    <a:ext uri="{9D8B030D-6E8A-4147-A177-3AD203B41FA5}">
                      <a16:colId xmlns:a16="http://schemas.microsoft.com/office/drawing/2014/main" val="2090896767"/>
                    </a:ext>
                  </a:extLst>
                </a:gridCol>
                <a:gridCol w="666750">
                  <a:extLst>
                    <a:ext uri="{9D8B030D-6E8A-4147-A177-3AD203B41FA5}">
                      <a16:colId xmlns:a16="http://schemas.microsoft.com/office/drawing/2014/main" val="300836238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Cancer Type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T0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T1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T2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T3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92502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Breast cancer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3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8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918192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Colorectal cancer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8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5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9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423913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Endometrial cancer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0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8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926023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Gastroesophageal cancer  </a:t>
                      </a:r>
                      <a:endParaRPr lang="en-US" b="0" i="0" dirty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1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8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19205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Head and neck squamous cell cancer (HNSCC)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5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37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3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8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357338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Hepatocellular carcinoma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4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9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5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1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54800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Melanoma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57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39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30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38712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Merkel cell carcinoma (MCC)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3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0842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Non-small cell lung cancer (NSCLC)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21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87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13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2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34068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Prostate cancer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1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62907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Renal cell carcinoma (RCC)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81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70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9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37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83830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Small cell lung cancer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54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4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90911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Urothelial </a:t>
                      </a:r>
                      <a:r>
                        <a:rPr lang="en-US" sz="1000" b="0" i="0" kern="120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+mn-ea"/>
                          <a:cs typeface="+mn-cs"/>
                        </a:rPr>
                        <a:t>carcinoma</a:t>
                      </a: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 (UC)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4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3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21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0" i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</a:rPr>
                        <a:t>16  </a:t>
                      </a:r>
                      <a:endParaRPr lang="en-US" b="0" i="0">
                        <a:effectLst/>
                      </a:endParaRP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1223529"/>
                  </a:ext>
                </a:extLst>
              </a:tr>
              <a:tr h="235317"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otal</a:t>
                      </a: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27</a:t>
                      </a: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21</a:t>
                      </a: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35</a:t>
                      </a: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ase">
                        <a:lnSpc>
                          <a:spcPts val="1395"/>
                        </a:lnSpc>
                      </a:pPr>
                      <a:r>
                        <a:rPr lang="en-US" sz="1000" b="1" i="0" dirty="0"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26</a:t>
                      </a:r>
                    </a:p>
                  </a:txBody>
                  <a:tcPr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9148052"/>
                  </a:ext>
                </a:extLst>
              </a:tr>
            </a:tbl>
          </a:graphicData>
        </a:graphic>
      </p:graphicFrame>
      <p:sp>
        <p:nvSpPr>
          <p:cNvPr id="11" name="Rectangle 2">
            <a:extLst>
              <a:ext uri="{FF2B5EF4-FFF2-40B4-BE49-F238E27FC236}">
                <a16:creationId xmlns:a16="http://schemas.microsoft.com/office/drawing/2014/main" id="{99675B56-B64A-62DD-2EB9-E4B2F4A8F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703" y="5665495"/>
            <a:ext cx="5557438" cy="307777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Supplementary 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Table S3. Successful samples by cancer type and timepoint.  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 Neue" panose="02000503000000020004" pitchFamily="2" charset="0"/>
              </a:rPr>
              <a:t>Successful samples defined as those processed and passing all QC metrics, regardless of ctDNA detection.   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4DF47BC-C15D-4B46-AC8D-72C5CBB88159}"/>
              </a:ext>
            </a:extLst>
          </p:cNvPr>
          <p:cNvSpPr txBox="1"/>
          <p:nvPr/>
        </p:nvSpPr>
        <p:spPr>
          <a:xfrm>
            <a:off x="286699" y="866282"/>
            <a:ext cx="34318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800" dirty="0">
                <a:latin typeface="Helvetica Neue"/>
                <a:ea typeface="Helvetica Neue" panose="02000503000000020004" pitchFamily="2" charset="0"/>
                <a:cs typeface="Helvetica Neue" panose="02000503000000020004" pitchFamily="2" charset="0"/>
              </a:rPr>
              <a:t>Supplementary Table S3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8756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Props1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9</TotalTime>
  <Words>146</Words>
  <Application>Microsoft Macintosh PowerPoint</Application>
  <PresentationFormat>Letter Paper (8.5x11 in)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4</cp:revision>
  <dcterms:created xsi:type="dcterms:W3CDTF">2024-12-13T18:22:33Z</dcterms:created>
  <dcterms:modified xsi:type="dcterms:W3CDTF">2025-07-09T17:07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